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hronological%20life%20span%20and%20storage%20carbohydrates\Cell%20viability%20and%20storage%20cabonhydrates%20in%20rimyakmck%20mutant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hronological%20life%20span%20and%20storage%20carbohydrates\Cell%20viability%20and%20storage%20cabonhydrates%20in%20rimyakmck%20mutant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hronological%20life%20span%20and%20storage%20carbohydrates\CFU%20and%20storage%20carbohydrates%20in%20gsy2tps1tsl1%20mutant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hronological%20life%20span%20and%20storage%20carbohydrates\CFU%20and%20storage%20carbohydrates%20in%20gsy2tps1tsl1%20mutant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hronological%20life%20span%20and%20storage%20carbohydrates\CFU%20and%20storage%20carbohydrates%20in%20gsy2tps1tsl1%20mutan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autoTitleDeleted val="1"/>
    <c:plotArea>
      <c:layout>
        <c:manualLayout>
          <c:layoutTarget val="inner"/>
          <c:xMode val="edge"/>
          <c:yMode val="edge"/>
          <c:x val="4.6381203373119816E-2"/>
          <c:y val="2.3202757962464755E-2"/>
          <c:w val="0.93851476344371998"/>
          <c:h val="0.92444268917795847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dLbls>
            <c:dLbl>
              <c:idx val="0"/>
              <c:layout/>
              <c:tx>
                <c:rich>
                  <a:bodyPr/>
                  <a:lstStyle/>
                  <a:p>
                    <a:pPr>
                      <a:defRPr i="0"/>
                    </a:pPr>
                    <a:r>
                      <a:rPr lang="en-GB" i="0"/>
                      <a:t>WT</a:t>
                    </a:r>
                  </a:p>
                </c:rich>
              </c:tx>
              <c:spPr/>
              <c:showVal val="1"/>
            </c:dLbl>
            <c:dLbl>
              <c:idx val="1"/>
              <c:layout>
                <c:manualLayout>
                  <c:x val="-0.18403752240089272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GB" i="1"/>
                      <a:t>r</a:t>
                    </a:r>
                    <a:r>
                      <a:rPr lang="en-GB"/>
                      <a:t>im15∆</a:t>
                    </a:r>
                  </a:p>
                </c:rich>
              </c:tx>
              <c:showVal val="1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GB" i="1"/>
                      <a:t>y</a:t>
                    </a:r>
                    <a:r>
                      <a:rPr lang="en-GB"/>
                      <a:t>ak1∆</a:t>
                    </a:r>
                  </a:p>
                </c:rich>
              </c:tx>
              <c:showVal val="1"/>
            </c:dLbl>
            <c:dLbl>
              <c:idx val="3"/>
              <c:layout>
                <c:manualLayout>
                  <c:x val="-7.6682301000371962E-3"/>
                  <c:y val="-2.0749320030895246E-2"/>
                </c:manualLayout>
              </c:layout>
              <c:tx>
                <c:rich>
                  <a:bodyPr/>
                  <a:lstStyle/>
                  <a:p>
                    <a:r>
                      <a:rPr lang="en-GB" i="1"/>
                      <a:t>m</a:t>
                    </a:r>
                    <a:r>
                      <a:rPr lang="en-GB"/>
                      <a:t>ck1∆</a:t>
                    </a:r>
                  </a:p>
                </c:rich>
              </c:tx>
              <c:showVal val="1"/>
            </c:dLbl>
            <c:delete val="1"/>
            <c:txPr>
              <a:bodyPr/>
              <a:lstStyle/>
              <a:p>
                <a:pPr>
                  <a:defRPr i="1"/>
                </a:pPr>
                <a:endParaRPr lang="en-US"/>
              </a:p>
            </c:txPr>
          </c:dLbls>
          <c:trendline>
            <c:trendlineType val="linear"/>
            <c:dispRSqr val="1"/>
            <c:trendlineLbl>
              <c:layout>
                <c:manualLayout>
                  <c:x val="-0.45436375124986139"/>
                  <c:y val="-4.3195371397731976E-2"/>
                </c:manualLayout>
              </c:layout>
              <c:tx>
                <c:rich>
                  <a:bodyPr/>
                  <a:lstStyle/>
                  <a:p>
                    <a:pPr>
                      <a:defRPr sz="1200" b="1"/>
                    </a:pPr>
                    <a:r>
                      <a:rPr lang="en-US" dirty="0"/>
                      <a:t>R² = </a:t>
                    </a:r>
                    <a:r>
                      <a:rPr lang="en-US" dirty="0" smtClean="0"/>
                      <a:t>0.78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errBars>
            <c:errDir val="y"/>
            <c:errBarType val="both"/>
            <c:errValType val="cust"/>
            <c:plus>
              <c:numRef>
                <c:f>Sheet1!$D$23:$D$30</c:f>
                <c:numCache>
                  <c:formatCode>General</c:formatCode>
                  <c:ptCount val="8"/>
                  <c:pt idx="0">
                    <c:v>3.6996145575243635</c:v>
                  </c:pt>
                  <c:pt idx="1">
                    <c:v>4.419244326424427</c:v>
                  </c:pt>
                  <c:pt idx="2">
                    <c:v>7.0806931038031431</c:v>
                  </c:pt>
                  <c:pt idx="3">
                    <c:v>9.4246227806588152</c:v>
                  </c:pt>
                  <c:pt idx="4">
                    <c:v>0.95693414782811048</c:v>
                  </c:pt>
                  <c:pt idx="5">
                    <c:v>2.4613623053398928</c:v>
                  </c:pt>
                  <c:pt idx="6">
                    <c:v>2.1350420507344983</c:v>
                  </c:pt>
                  <c:pt idx="7">
                    <c:v>0.30280608523931429</c:v>
                  </c:pt>
                </c:numCache>
              </c:numRef>
            </c:plus>
            <c:minus>
              <c:numRef>
                <c:f>Sheet1!$D$23:$D$30</c:f>
                <c:numCache>
                  <c:formatCode>General</c:formatCode>
                  <c:ptCount val="8"/>
                  <c:pt idx="0">
                    <c:v>3.6996145575243635</c:v>
                  </c:pt>
                  <c:pt idx="1">
                    <c:v>4.419244326424427</c:v>
                  </c:pt>
                  <c:pt idx="2">
                    <c:v>7.0806931038031431</c:v>
                  </c:pt>
                  <c:pt idx="3">
                    <c:v>9.4246227806588152</c:v>
                  </c:pt>
                  <c:pt idx="4">
                    <c:v>0.95693414782811048</c:v>
                  </c:pt>
                  <c:pt idx="5">
                    <c:v>2.4613623053398928</c:v>
                  </c:pt>
                  <c:pt idx="6">
                    <c:v>2.1350420507344983</c:v>
                  </c:pt>
                  <c:pt idx="7">
                    <c:v>0.30280608523931429</c:v>
                  </c:pt>
                </c:numCache>
              </c:numRef>
            </c:minus>
          </c:errBars>
          <c:xVal>
            <c:numRef>
              <c:f>Sheet1!$B$23:$B$30</c:f>
              <c:numCache>
                <c:formatCode>General</c:formatCode>
                <c:ptCount val="8"/>
                <c:pt idx="0">
                  <c:v>35.674970998500385</c:v>
                </c:pt>
                <c:pt idx="1">
                  <c:v>8.9512008507106344</c:v>
                </c:pt>
                <c:pt idx="2">
                  <c:v>27.577724018900554</c:v>
                </c:pt>
                <c:pt idx="3">
                  <c:v>11.922990687503065</c:v>
                </c:pt>
                <c:pt idx="4">
                  <c:v>5.613059326294632</c:v>
                </c:pt>
                <c:pt idx="5">
                  <c:v>2.500919117647058</c:v>
                </c:pt>
                <c:pt idx="6">
                  <c:v>10.434923793336901</c:v>
                </c:pt>
                <c:pt idx="7">
                  <c:v>2.552475770670025</c:v>
                </c:pt>
              </c:numCache>
            </c:numRef>
          </c:xVal>
          <c:yVal>
            <c:numRef>
              <c:f>Sheet1!$C$23:$C$30</c:f>
              <c:numCache>
                <c:formatCode>General</c:formatCode>
                <c:ptCount val="8"/>
                <c:pt idx="0">
                  <c:v>129.64169381107493</c:v>
                </c:pt>
                <c:pt idx="1">
                  <c:v>71.238938053097314</c:v>
                </c:pt>
                <c:pt idx="2">
                  <c:v>122.4880382775119</c:v>
                </c:pt>
                <c:pt idx="3">
                  <c:v>73.366834170854204</c:v>
                </c:pt>
                <c:pt idx="4">
                  <c:v>4.4198895027624303</c:v>
                </c:pt>
                <c:pt idx="5">
                  <c:v>11.631944444444445</c:v>
                </c:pt>
                <c:pt idx="6">
                  <c:v>90.598290598290603</c:v>
                </c:pt>
                <c:pt idx="7">
                  <c:v>3.3216783216783203</c:v>
                </c:pt>
              </c:numCache>
            </c:numRef>
          </c:yVal>
        </c:ser>
        <c:axId val="77635584"/>
        <c:axId val="77637120"/>
      </c:scatterChart>
      <c:valAx>
        <c:axId val="77635584"/>
        <c:scaling>
          <c:orientation val="minMax"/>
        </c:scaling>
        <c:axPos val="b"/>
        <c:numFmt formatCode="General" sourceLinked="1"/>
        <c:tickLblPos val="nextTo"/>
        <c:crossAx val="77637120"/>
        <c:crosses val="autoZero"/>
        <c:crossBetween val="midCat"/>
      </c:valAx>
      <c:valAx>
        <c:axId val="77637120"/>
        <c:scaling>
          <c:orientation val="minMax"/>
          <c:max val="150"/>
          <c:min val="0"/>
        </c:scaling>
        <c:axPos val="l"/>
        <c:majorGridlines/>
        <c:numFmt formatCode="General" sourceLinked="1"/>
        <c:tickLblPos val="nextTo"/>
        <c:crossAx val="77635584"/>
        <c:crosses val="autoZero"/>
        <c:crossBetween val="midCat"/>
        <c:majorUnit val="30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autoTitleDeleted val="1"/>
    <c:plotArea>
      <c:layout/>
      <c:scatterChart>
        <c:scatterStyle val="lineMarker"/>
        <c:ser>
          <c:idx val="0"/>
          <c:order val="0"/>
          <c:spPr>
            <a:ln w="28575">
              <a:noFill/>
            </a:ln>
          </c:spP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GB"/>
                      <a:t>WT</a:t>
                    </a:r>
                  </a:p>
                </c:rich>
              </c:tx>
              <c:showVal val="1"/>
            </c:dLbl>
            <c:dLbl>
              <c:idx val="1"/>
              <c:layout>
                <c:manualLayout>
                  <c:x val="-3.2812891590856832E-2"/>
                  <c:y val="-3.8580782690812131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rim15∆</a:t>
                    </a:r>
                  </a:p>
                </c:rich>
              </c:tx>
              <c:showVal val="1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GB"/>
                      <a:t>yak1∆</a:t>
                    </a:r>
                  </a:p>
                </c:rich>
              </c:tx>
              <c:showVal val="1"/>
            </c:dLbl>
            <c:dLbl>
              <c:idx val="3"/>
              <c:layout>
                <c:manualLayout>
                  <c:x val="4.1016114488571058E-3"/>
                  <c:y val="-5.511974363959663E-3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mck1∆</a:t>
                    </a:r>
                  </a:p>
                </c:rich>
              </c:tx>
              <c:showVal val="1"/>
            </c:dLbl>
            <c:delete val="1"/>
          </c:dLbls>
          <c:trendline>
            <c:trendlineType val="linear"/>
            <c:dispRSqr val="1"/>
            <c:trendlineLbl>
              <c:layout>
                <c:manualLayout>
                  <c:x val="-0.42608370808927781"/>
                  <c:y val="-0.17800452727474719"/>
                </c:manualLayout>
              </c:layout>
              <c:tx>
                <c:rich>
                  <a:bodyPr/>
                  <a:lstStyle/>
                  <a:p>
                    <a:pPr>
                      <a:defRPr sz="1200" b="1"/>
                    </a:pPr>
                    <a:r>
                      <a:rPr lang="en-US" dirty="0"/>
                      <a:t>R² = </a:t>
                    </a:r>
                    <a:r>
                      <a:rPr lang="en-US" dirty="0" smtClean="0"/>
                      <a:t>0.78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errBars>
            <c:errDir val="y"/>
            <c:errBarType val="both"/>
            <c:errValType val="cust"/>
            <c:plus>
              <c:numRef>
                <c:f>Sheet1!$F$23:$F$30</c:f>
                <c:numCache>
                  <c:formatCode>General</c:formatCode>
                  <c:ptCount val="8"/>
                  <c:pt idx="0">
                    <c:v>7.0692294508827098</c:v>
                  </c:pt>
                  <c:pt idx="1">
                    <c:v>4.3184117911378674</c:v>
                  </c:pt>
                  <c:pt idx="2">
                    <c:v>1.2430986657192895</c:v>
                  </c:pt>
                  <c:pt idx="3">
                    <c:v>3.4815091609424722</c:v>
                  </c:pt>
                  <c:pt idx="4">
                    <c:v>0.9569341478281036</c:v>
                  </c:pt>
                  <c:pt idx="5">
                    <c:v>1.2028130608117253</c:v>
                  </c:pt>
                  <c:pt idx="6">
                    <c:v>0.78334627264202361</c:v>
                  </c:pt>
                  <c:pt idx="7">
                    <c:v>0.60561217047862859</c:v>
                  </c:pt>
                </c:numCache>
              </c:numRef>
            </c:plus>
            <c:minus>
              <c:numRef>
                <c:f>Sheet1!$F$23:$F$30</c:f>
                <c:numCache>
                  <c:formatCode>General</c:formatCode>
                  <c:ptCount val="8"/>
                  <c:pt idx="0">
                    <c:v>7.0692294508827098</c:v>
                  </c:pt>
                  <c:pt idx="1">
                    <c:v>4.3184117911378674</c:v>
                  </c:pt>
                  <c:pt idx="2">
                    <c:v>1.2430986657192895</c:v>
                  </c:pt>
                  <c:pt idx="3">
                    <c:v>3.4815091609424722</c:v>
                  </c:pt>
                  <c:pt idx="4">
                    <c:v>0.9569341478281036</c:v>
                  </c:pt>
                  <c:pt idx="5">
                    <c:v>1.2028130608117253</c:v>
                  </c:pt>
                  <c:pt idx="6">
                    <c:v>0.78334627264202361</c:v>
                  </c:pt>
                  <c:pt idx="7">
                    <c:v>0.60561217047862859</c:v>
                  </c:pt>
                </c:numCache>
              </c:numRef>
            </c:minus>
          </c:errBars>
          <c:xVal>
            <c:numRef>
              <c:f>Sheet1!$B$23:$B$30</c:f>
              <c:numCache>
                <c:formatCode>General</c:formatCode>
                <c:ptCount val="8"/>
                <c:pt idx="0">
                  <c:v>35.674970998500385</c:v>
                </c:pt>
                <c:pt idx="1">
                  <c:v>8.9512008507106344</c:v>
                </c:pt>
                <c:pt idx="2">
                  <c:v>27.577724018900554</c:v>
                </c:pt>
                <c:pt idx="3">
                  <c:v>11.922990687503065</c:v>
                </c:pt>
                <c:pt idx="4">
                  <c:v>5.613059326294632</c:v>
                </c:pt>
                <c:pt idx="5">
                  <c:v>2.500919117647058</c:v>
                </c:pt>
                <c:pt idx="6">
                  <c:v>10.434923793336901</c:v>
                </c:pt>
                <c:pt idx="7">
                  <c:v>2.552475770670025</c:v>
                </c:pt>
              </c:numCache>
            </c:numRef>
          </c:xVal>
          <c:yVal>
            <c:numRef>
              <c:f>Sheet1!$E$23:$E$30</c:f>
              <c:numCache>
                <c:formatCode>General</c:formatCode>
                <c:ptCount val="8"/>
                <c:pt idx="0">
                  <c:v>136.15635179153088</c:v>
                </c:pt>
                <c:pt idx="1">
                  <c:v>18.141592920353986</c:v>
                </c:pt>
                <c:pt idx="2">
                  <c:v>44.497607655502357</c:v>
                </c:pt>
                <c:pt idx="3">
                  <c:v>11.809045226130658</c:v>
                </c:pt>
                <c:pt idx="4">
                  <c:v>4.9723756906077368</c:v>
                </c:pt>
                <c:pt idx="5">
                  <c:v>4.8611111111111107</c:v>
                </c:pt>
                <c:pt idx="6">
                  <c:v>47.008547008547005</c:v>
                </c:pt>
                <c:pt idx="7">
                  <c:v>4.895104895104895</c:v>
                </c:pt>
              </c:numCache>
            </c:numRef>
          </c:yVal>
        </c:ser>
        <c:axId val="80832000"/>
        <c:axId val="80833536"/>
      </c:scatterChart>
      <c:valAx>
        <c:axId val="80832000"/>
        <c:scaling>
          <c:orientation val="minMax"/>
        </c:scaling>
        <c:axPos val="b"/>
        <c:numFmt formatCode="General" sourceLinked="1"/>
        <c:tickLblPos val="nextTo"/>
        <c:crossAx val="80833536"/>
        <c:crosses val="autoZero"/>
        <c:crossBetween val="midCat"/>
      </c:valAx>
      <c:valAx>
        <c:axId val="80833536"/>
        <c:scaling>
          <c:orientation val="minMax"/>
          <c:max val="150"/>
          <c:min val="0"/>
        </c:scaling>
        <c:axPos val="l"/>
        <c:majorGridlines/>
        <c:numFmt formatCode="General" sourceLinked="1"/>
        <c:tickLblPos val="nextTo"/>
        <c:crossAx val="80832000"/>
        <c:crosses val="autoZero"/>
        <c:crossBetween val="midCat"/>
        <c:majorUnit val="30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>
        <c:manualLayout>
          <c:layoutTarget val="inner"/>
          <c:xMode val="edge"/>
          <c:yMode val="edge"/>
          <c:x val="0.13662370847683589"/>
          <c:y val="6.3165920632474518E-2"/>
          <c:w val="0.81457719975558252"/>
          <c:h val="0.81488590103297953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dLbls>
            <c:dLbl>
              <c:idx val="0"/>
              <c:layout/>
              <c:tx>
                <c:rich>
                  <a:bodyPr/>
                  <a:lstStyle/>
                  <a:p>
                    <a:pPr>
                      <a:defRPr i="0"/>
                    </a:pPr>
                    <a:r>
                      <a:rPr lang="en-GB" i="0"/>
                      <a:t>WT</a:t>
                    </a:r>
                  </a:p>
                </c:rich>
              </c:tx>
              <c:spPr/>
              <c:showVal val="1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GB" i="1"/>
                      <a:t>g</a:t>
                    </a:r>
                    <a:r>
                      <a:rPr lang="en-GB"/>
                      <a:t>sy2∆</a:t>
                    </a:r>
                  </a:p>
                </c:rich>
              </c:tx>
              <c:showVal val="1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GB" i="1"/>
                      <a:t>t</a:t>
                    </a:r>
                    <a:r>
                      <a:rPr lang="en-GB"/>
                      <a:t>ps1∆</a:t>
                    </a:r>
                  </a:p>
                </c:rich>
              </c:tx>
              <c:showVal val="1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GB" i="1"/>
                      <a:t>t</a:t>
                    </a:r>
                    <a:r>
                      <a:rPr lang="en-GB"/>
                      <a:t>sl1∆</a:t>
                    </a:r>
                  </a:p>
                </c:rich>
              </c:tx>
              <c:showVal val="1"/>
            </c:dLbl>
            <c:delete val="1"/>
            <c:txPr>
              <a:bodyPr/>
              <a:lstStyle/>
              <a:p>
                <a:pPr>
                  <a:defRPr i="1"/>
                </a:pPr>
                <a:endParaRPr lang="en-US"/>
              </a:p>
            </c:txPr>
          </c:dLbls>
          <c:trendline>
            <c:trendlineType val="linear"/>
            <c:dispRSqr val="1"/>
            <c:trendlineLbl>
              <c:layout>
                <c:manualLayout>
                  <c:x val="-0.38429857000015882"/>
                  <c:y val="-0.15065622529308295"/>
                </c:manualLayout>
              </c:layout>
              <c:tx>
                <c:rich>
                  <a:bodyPr/>
                  <a:lstStyle/>
                  <a:p>
                    <a:pPr>
                      <a:defRPr sz="1200" b="1"/>
                    </a:pPr>
                    <a:r>
                      <a:rPr lang="en-US" dirty="0"/>
                      <a:t>R² = </a:t>
                    </a:r>
                    <a:r>
                      <a:rPr lang="en-US" dirty="0" smtClean="0"/>
                      <a:t>0.09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errBars>
            <c:errDir val="y"/>
            <c:errBarType val="both"/>
            <c:errValType val="cust"/>
            <c:plus>
              <c:numRef>
                <c:f>Sheet1!$E$2:$E$7</c:f>
                <c:numCache>
                  <c:formatCode>General</c:formatCode>
                  <c:ptCount val="6"/>
                  <c:pt idx="0">
                    <c:v>9.8015248874580205</c:v>
                  </c:pt>
                  <c:pt idx="1">
                    <c:v>8.1995043571754636</c:v>
                  </c:pt>
                  <c:pt idx="2">
                    <c:v>4.4095802838996168</c:v>
                  </c:pt>
                  <c:pt idx="3">
                    <c:v>9.3276083725250452</c:v>
                  </c:pt>
                  <c:pt idx="4">
                    <c:v>1.537323201984212</c:v>
                  </c:pt>
                  <c:pt idx="5">
                    <c:v>6.1537101086992374</c:v>
                  </c:pt>
                </c:numCache>
              </c:numRef>
            </c:plus>
            <c:minus>
              <c:numRef>
                <c:f>Sheet1!$E$2:$E$7</c:f>
                <c:numCache>
                  <c:formatCode>General</c:formatCode>
                  <c:ptCount val="6"/>
                  <c:pt idx="0">
                    <c:v>9.8015248874580205</c:v>
                  </c:pt>
                  <c:pt idx="1">
                    <c:v>8.1995043571754636</c:v>
                  </c:pt>
                  <c:pt idx="2">
                    <c:v>4.4095802838996168</c:v>
                  </c:pt>
                  <c:pt idx="3">
                    <c:v>9.3276083725250452</c:v>
                  </c:pt>
                  <c:pt idx="4">
                    <c:v>1.537323201984212</c:v>
                  </c:pt>
                  <c:pt idx="5">
                    <c:v>6.1537101086992374</c:v>
                  </c:pt>
                </c:numCache>
              </c:numRef>
            </c:minus>
          </c:errBars>
          <c:xVal>
            <c:numRef>
              <c:f>Sheet1!$B$2:$B$7</c:f>
              <c:numCache>
                <c:formatCode>General</c:formatCode>
                <c:ptCount val="6"/>
                <c:pt idx="0">
                  <c:v>12.845030617038455</c:v>
                </c:pt>
                <c:pt idx="1">
                  <c:v>1.4344910695412549</c:v>
                </c:pt>
                <c:pt idx="2">
                  <c:v>21.831233108271636</c:v>
                </c:pt>
                <c:pt idx="3">
                  <c:v>20.526284310151667</c:v>
                </c:pt>
                <c:pt idx="4">
                  <c:v>1.1189986699748979</c:v>
                </c:pt>
                <c:pt idx="5">
                  <c:v>1.7768050317777766</c:v>
                </c:pt>
              </c:numCache>
            </c:numRef>
          </c:xVal>
          <c:yVal>
            <c:numRef>
              <c:f>Sheet1!$C$2:$C$7</c:f>
              <c:numCache>
                <c:formatCode>General</c:formatCode>
                <c:ptCount val="6"/>
                <c:pt idx="0">
                  <c:v>117.26283048211509</c:v>
                </c:pt>
                <c:pt idx="1">
                  <c:v>124.08759124087592</c:v>
                </c:pt>
                <c:pt idx="2">
                  <c:v>77.195685670261938</c:v>
                </c:pt>
                <c:pt idx="3">
                  <c:v>133.87096774193549</c:v>
                </c:pt>
                <c:pt idx="4">
                  <c:v>5.7692307692307692</c:v>
                </c:pt>
                <c:pt idx="5">
                  <c:v>108.75232774674114</c:v>
                </c:pt>
              </c:numCache>
            </c:numRef>
          </c:yVal>
        </c:ser>
        <c:axId val="80782464"/>
        <c:axId val="80784000"/>
      </c:scatterChart>
      <c:valAx>
        <c:axId val="80782464"/>
        <c:scaling>
          <c:orientation val="minMax"/>
        </c:scaling>
        <c:axPos val="b"/>
        <c:numFmt formatCode="General" sourceLinked="1"/>
        <c:tickLblPos val="nextTo"/>
        <c:crossAx val="80784000"/>
        <c:crosses val="autoZero"/>
        <c:crossBetween val="midCat"/>
      </c:valAx>
      <c:valAx>
        <c:axId val="80784000"/>
        <c:scaling>
          <c:orientation val="minMax"/>
          <c:max val="150"/>
          <c:min val="0"/>
        </c:scaling>
        <c:axPos val="l"/>
        <c:majorGridlines/>
        <c:numFmt formatCode="General" sourceLinked="1"/>
        <c:tickLblPos val="nextTo"/>
        <c:crossAx val="80782464"/>
        <c:crosses val="autoZero"/>
        <c:crossBetween val="midCat"/>
        <c:majorUnit val="30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plotArea>
      <c:layout>
        <c:manualLayout>
          <c:layoutTarget val="inner"/>
          <c:xMode val="edge"/>
          <c:yMode val="edge"/>
          <c:x val="0.15180417908973814"/>
          <c:y val="6.5271451320223703E-2"/>
          <c:w val="0.76947884242755571"/>
          <c:h val="0.81684535051660945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dLbls>
            <c:dLbl>
              <c:idx val="0"/>
              <c:layout>
                <c:manualLayout>
                  <c:x val="-1.4300218256612061E-2"/>
                  <c:y val="4.2571898141585796E-2"/>
                </c:manualLayout>
              </c:layout>
              <c:tx>
                <c:rich>
                  <a:bodyPr/>
                  <a:lstStyle/>
                  <a:p>
                    <a:pPr>
                      <a:defRPr i="0"/>
                    </a:pPr>
                    <a:r>
                      <a:rPr lang="en-GB" i="0"/>
                      <a:t>WT</a:t>
                    </a:r>
                  </a:p>
                </c:rich>
              </c:tx>
              <c:spPr/>
              <c:showVal val="1"/>
            </c:dLbl>
            <c:dLbl>
              <c:idx val="1"/>
              <c:layout>
                <c:manualLayout>
                  <c:x val="1.4300218256611978E-2"/>
                  <c:y val="-1.2163399469024515E-2"/>
                </c:manualLayout>
              </c:layout>
              <c:tx>
                <c:rich>
                  <a:bodyPr/>
                  <a:lstStyle/>
                  <a:p>
                    <a:r>
                      <a:rPr lang="en-GB" i="1"/>
                      <a:t>g</a:t>
                    </a:r>
                    <a:r>
                      <a:rPr lang="en-GB"/>
                      <a:t>sy2∆</a:t>
                    </a:r>
                  </a:p>
                </c:rich>
              </c:tx>
              <c:showVal val="1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GB" i="1"/>
                      <a:t>t</a:t>
                    </a:r>
                    <a:r>
                      <a:rPr lang="en-GB"/>
                      <a:t>ps1∆</a:t>
                    </a:r>
                  </a:p>
                </c:rich>
              </c:tx>
              <c:showVal val="1"/>
            </c:dLbl>
            <c:dLbl>
              <c:idx val="3"/>
              <c:layout>
                <c:manualLayout>
                  <c:x val="-9.5334788377413222E-3"/>
                  <c:y val="-3.040849867256129E-2"/>
                </c:manualLayout>
              </c:layout>
              <c:tx>
                <c:rich>
                  <a:bodyPr/>
                  <a:lstStyle/>
                  <a:p>
                    <a:r>
                      <a:rPr lang="en-GB" i="1"/>
                      <a:t>t</a:t>
                    </a:r>
                    <a:r>
                      <a:rPr lang="en-GB"/>
                      <a:t>sl1∆</a:t>
                    </a:r>
                  </a:p>
                </c:rich>
              </c:tx>
              <c:showVal val="1"/>
            </c:dLbl>
            <c:delete val="1"/>
            <c:txPr>
              <a:bodyPr/>
              <a:lstStyle/>
              <a:p>
                <a:pPr>
                  <a:defRPr i="1"/>
                </a:pPr>
                <a:endParaRPr lang="en-US"/>
              </a:p>
            </c:txPr>
          </c:dLbls>
          <c:trendline>
            <c:trendlineType val="linear"/>
            <c:dispRSqr val="1"/>
            <c:trendlineLbl>
              <c:layout>
                <c:manualLayout>
                  <c:x val="-0.33658510037364503"/>
                  <c:y val="-6.1664604315995554E-2"/>
                </c:manualLayout>
              </c:layout>
              <c:tx>
                <c:rich>
                  <a:bodyPr/>
                  <a:lstStyle/>
                  <a:p>
                    <a:pPr>
                      <a:defRPr sz="1200" b="1"/>
                    </a:pPr>
                    <a:r>
                      <a:rPr lang="en-US" dirty="0"/>
                      <a:t>R² = </a:t>
                    </a:r>
                    <a:r>
                      <a:rPr lang="en-US" dirty="0" smtClean="0"/>
                      <a:t>0.73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errBars>
            <c:errDir val="y"/>
            <c:errBarType val="both"/>
            <c:errValType val="cust"/>
            <c:plus>
              <c:numRef>
                <c:f>Sheet1!$K$2:$K$7</c:f>
                <c:numCache>
                  <c:formatCode>General</c:formatCode>
                  <c:ptCount val="6"/>
                  <c:pt idx="0">
                    <c:v>9.8015248874580205</c:v>
                  </c:pt>
                  <c:pt idx="1">
                    <c:v>8.1995043571754636</c:v>
                  </c:pt>
                  <c:pt idx="2">
                    <c:v>4.4095802838996168</c:v>
                  </c:pt>
                  <c:pt idx="3">
                    <c:v>9.3276083725250452</c:v>
                  </c:pt>
                  <c:pt idx="4">
                    <c:v>1.537323201984212</c:v>
                  </c:pt>
                  <c:pt idx="5">
                    <c:v>6.1537101086992374</c:v>
                  </c:pt>
                </c:numCache>
              </c:numRef>
            </c:plus>
            <c:minus>
              <c:numRef>
                <c:f>Sheet1!$K$2:$K$7</c:f>
                <c:numCache>
                  <c:formatCode>General</c:formatCode>
                  <c:ptCount val="6"/>
                  <c:pt idx="0">
                    <c:v>9.8015248874580205</c:v>
                  </c:pt>
                  <c:pt idx="1">
                    <c:v>8.1995043571754636</c:v>
                  </c:pt>
                  <c:pt idx="2">
                    <c:v>4.4095802838996168</c:v>
                  </c:pt>
                  <c:pt idx="3">
                    <c:v>9.3276083725250452</c:v>
                  </c:pt>
                  <c:pt idx="4">
                    <c:v>1.537323201984212</c:v>
                  </c:pt>
                  <c:pt idx="5">
                    <c:v>6.1537101086992374</c:v>
                  </c:pt>
                </c:numCache>
              </c:numRef>
            </c:minus>
          </c:errBars>
          <c:xVal>
            <c:numRef>
              <c:f>Sheet1!$H$2:$H$7</c:f>
              <c:numCache>
                <c:formatCode>General</c:formatCode>
                <c:ptCount val="6"/>
                <c:pt idx="0">
                  <c:v>32.070191014831316</c:v>
                </c:pt>
                <c:pt idx="1">
                  <c:v>31.794816053572131</c:v>
                </c:pt>
                <c:pt idx="2">
                  <c:v>0.54022138730002178</c:v>
                </c:pt>
                <c:pt idx="3">
                  <c:v>27.658223334080102</c:v>
                </c:pt>
                <c:pt idx="4">
                  <c:v>0.60118376058594958</c:v>
                </c:pt>
                <c:pt idx="5">
                  <c:v>25.96325874041759</c:v>
                </c:pt>
              </c:numCache>
            </c:numRef>
          </c:xVal>
          <c:yVal>
            <c:numRef>
              <c:f>Sheet1!$I$2:$I$7</c:f>
              <c:numCache>
                <c:formatCode>General</c:formatCode>
                <c:ptCount val="6"/>
                <c:pt idx="0">
                  <c:v>117.26283048211509</c:v>
                </c:pt>
                <c:pt idx="1">
                  <c:v>124.08759124087592</c:v>
                </c:pt>
                <c:pt idx="2">
                  <c:v>77.195685670261938</c:v>
                </c:pt>
                <c:pt idx="3">
                  <c:v>133.87096774193549</c:v>
                </c:pt>
                <c:pt idx="4">
                  <c:v>5.7692307692307692</c:v>
                </c:pt>
                <c:pt idx="5">
                  <c:v>108.75232774674114</c:v>
                </c:pt>
              </c:numCache>
            </c:numRef>
          </c:yVal>
        </c:ser>
        <c:axId val="82759680"/>
        <c:axId val="82761216"/>
      </c:scatterChart>
      <c:valAx>
        <c:axId val="82759680"/>
        <c:scaling>
          <c:orientation val="minMax"/>
        </c:scaling>
        <c:axPos val="b"/>
        <c:numFmt formatCode="General" sourceLinked="1"/>
        <c:tickLblPos val="nextTo"/>
        <c:crossAx val="82761216"/>
        <c:crosses val="autoZero"/>
        <c:crossBetween val="midCat"/>
      </c:valAx>
      <c:valAx>
        <c:axId val="82761216"/>
        <c:scaling>
          <c:orientation val="minMax"/>
          <c:max val="150"/>
          <c:min val="0"/>
        </c:scaling>
        <c:axPos val="l"/>
        <c:majorGridlines/>
        <c:numFmt formatCode="General" sourceLinked="1"/>
        <c:tickLblPos val="nextTo"/>
        <c:crossAx val="82759680"/>
        <c:crosses val="autoZero"/>
        <c:crossBetween val="midCat"/>
        <c:majorUnit val="30"/>
      </c:valAx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/>
      <c:scatterChart>
        <c:scatterStyle val="lineMarker"/>
        <c:ser>
          <c:idx val="0"/>
          <c:order val="0"/>
          <c:spPr>
            <a:ln w="28575">
              <a:noFill/>
            </a:ln>
          </c:spPr>
          <c:dLbls>
            <c:dLbl>
              <c:idx val="0"/>
              <c:layout>
                <c:manualLayout>
                  <c:x val="-1.0226676589828956E-16"/>
                  <c:y val="3.5273858460171115E-2"/>
                </c:manualLayout>
              </c:layout>
              <c:tx>
                <c:rich>
                  <a:bodyPr/>
                  <a:lstStyle/>
                  <a:p>
                    <a:pPr>
                      <a:defRPr i="0"/>
                    </a:pPr>
                    <a:r>
                      <a:rPr lang="en-GB" i="0"/>
                      <a:t>WT</a:t>
                    </a:r>
                  </a:p>
                </c:rich>
              </c:tx>
              <c:spPr/>
              <c:showVal val="1"/>
            </c:dLbl>
            <c:dLbl>
              <c:idx val="1"/>
              <c:layout>
                <c:manualLayout>
                  <c:x val="-7.8095523387149562E-2"/>
                  <c:y val="-8.818557197348445E-2"/>
                </c:manualLayout>
              </c:layout>
              <c:tx>
                <c:rich>
                  <a:bodyPr/>
                  <a:lstStyle/>
                  <a:p>
                    <a:r>
                      <a:rPr lang="en-GB" i="1"/>
                      <a:t>g</a:t>
                    </a:r>
                    <a:r>
                      <a:rPr lang="en-GB"/>
                      <a:t>sy2∆</a:t>
                    </a:r>
                  </a:p>
                </c:rich>
              </c:tx>
              <c:showVal val="1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GB" i="1"/>
                      <a:t>t</a:t>
                    </a:r>
                    <a:r>
                      <a:rPr lang="en-GB"/>
                      <a:t>ps1∆</a:t>
                    </a:r>
                  </a:p>
                </c:rich>
              </c:tx>
              <c:showVal val="1"/>
            </c:dLbl>
            <c:dLbl>
              <c:idx val="3"/>
              <c:layout>
                <c:manualLayout>
                  <c:x val="-5.5782516705106871E-3"/>
                  <c:y val="-3.5273858460171115E-2"/>
                </c:manualLayout>
              </c:layout>
              <c:tx>
                <c:rich>
                  <a:bodyPr/>
                  <a:lstStyle/>
                  <a:p>
                    <a:r>
                      <a:rPr lang="en-GB" i="1"/>
                      <a:t>t</a:t>
                    </a:r>
                    <a:r>
                      <a:rPr lang="en-GB"/>
                      <a:t>sl1∆</a:t>
                    </a:r>
                  </a:p>
                </c:rich>
              </c:tx>
              <c:showVal val="1"/>
            </c:dLbl>
            <c:delete val="1"/>
            <c:txPr>
              <a:bodyPr/>
              <a:lstStyle/>
              <a:p>
                <a:pPr>
                  <a:defRPr i="1"/>
                </a:pPr>
                <a:endParaRPr lang="en-US"/>
              </a:p>
            </c:txPr>
          </c:dLbls>
          <c:trendline>
            <c:trendlineType val="linear"/>
            <c:dispRSqr val="1"/>
            <c:trendlineLbl>
              <c:layout>
                <c:manualLayout>
                  <c:x val="-0.25101517591917083"/>
                  <c:y val="-2.9997592860052588E-2"/>
                </c:manualLayout>
              </c:layout>
              <c:tx>
                <c:rich>
                  <a:bodyPr/>
                  <a:lstStyle/>
                  <a:p>
                    <a:pPr>
                      <a:defRPr sz="1200" b="1"/>
                    </a:pPr>
                    <a:r>
                      <a:rPr lang="en-US" dirty="0"/>
                      <a:t>R² = </a:t>
                    </a:r>
                    <a:r>
                      <a:rPr lang="en-US" dirty="0" smtClean="0"/>
                      <a:t>0.88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errBars>
            <c:errDir val="y"/>
            <c:errBarType val="both"/>
            <c:errValType val="cust"/>
            <c:plus>
              <c:numRef>
                <c:f>Sheet1!$Q$2:$Q$7</c:f>
                <c:numCache>
                  <c:formatCode>General</c:formatCode>
                  <c:ptCount val="6"/>
                  <c:pt idx="0">
                    <c:v>9.8015248874580205</c:v>
                  </c:pt>
                  <c:pt idx="1">
                    <c:v>8.1995043571754636</c:v>
                  </c:pt>
                  <c:pt idx="2">
                    <c:v>4.4095802838996168</c:v>
                  </c:pt>
                  <c:pt idx="3">
                    <c:v>9.3276083725250452</c:v>
                  </c:pt>
                  <c:pt idx="4">
                    <c:v>1.537323201984212</c:v>
                  </c:pt>
                  <c:pt idx="5">
                    <c:v>6.1537101086992374</c:v>
                  </c:pt>
                </c:numCache>
              </c:numRef>
            </c:plus>
            <c:minus>
              <c:numRef>
                <c:f>Sheet1!$Q$2:$Q$7</c:f>
                <c:numCache>
                  <c:formatCode>General</c:formatCode>
                  <c:ptCount val="6"/>
                  <c:pt idx="0">
                    <c:v>9.8015248874580205</c:v>
                  </c:pt>
                  <c:pt idx="1">
                    <c:v>8.1995043571754636</c:v>
                  </c:pt>
                  <c:pt idx="2">
                    <c:v>4.4095802838996168</c:v>
                  </c:pt>
                  <c:pt idx="3">
                    <c:v>9.3276083725250452</c:v>
                  </c:pt>
                  <c:pt idx="4">
                    <c:v>1.537323201984212</c:v>
                  </c:pt>
                  <c:pt idx="5">
                    <c:v>6.1537101086992374</c:v>
                  </c:pt>
                </c:numCache>
              </c:numRef>
            </c:minus>
          </c:errBars>
          <c:xVal>
            <c:numRef>
              <c:f>Sheet1!$N$2:$N$7</c:f>
              <c:numCache>
                <c:formatCode>General</c:formatCode>
                <c:ptCount val="6"/>
                <c:pt idx="0">
                  <c:v>44.91522163186977</c:v>
                </c:pt>
                <c:pt idx="1">
                  <c:v>33.229307123113401</c:v>
                </c:pt>
                <c:pt idx="2">
                  <c:v>22.371454495571658</c:v>
                </c:pt>
                <c:pt idx="3">
                  <c:v>48.184507644231772</c:v>
                </c:pt>
                <c:pt idx="4">
                  <c:v>1.720182430560848</c:v>
                </c:pt>
                <c:pt idx="5">
                  <c:v>27.740063772195359</c:v>
                </c:pt>
              </c:numCache>
            </c:numRef>
          </c:xVal>
          <c:yVal>
            <c:numRef>
              <c:f>Sheet1!$O$2:$O$7</c:f>
              <c:numCache>
                <c:formatCode>General</c:formatCode>
                <c:ptCount val="6"/>
                <c:pt idx="0">
                  <c:v>117.26283048211509</c:v>
                </c:pt>
                <c:pt idx="1">
                  <c:v>124.08759124087592</c:v>
                </c:pt>
                <c:pt idx="2">
                  <c:v>77.195685670261938</c:v>
                </c:pt>
                <c:pt idx="3">
                  <c:v>133.87096774193549</c:v>
                </c:pt>
                <c:pt idx="4">
                  <c:v>5.7692307692307692</c:v>
                </c:pt>
                <c:pt idx="5">
                  <c:v>108.75232774674114</c:v>
                </c:pt>
              </c:numCache>
            </c:numRef>
          </c:yVal>
        </c:ser>
        <c:axId val="82852096"/>
        <c:axId val="82870272"/>
      </c:scatterChart>
      <c:valAx>
        <c:axId val="82852096"/>
        <c:scaling>
          <c:orientation val="minMax"/>
        </c:scaling>
        <c:axPos val="b"/>
        <c:numFmt formatCode="General" sourceLinked="1"/>
        <c:tickLblPos val="nextTo"/>
        <c:crossAx val="82870272"/>
        <c:crosses val="autoZero"/>
        <c:crossBetween val="midCat"/>
      </c:valAx>
      <c:valAx>
        <c:axId val="82870272"/>
        <c:scaling>
          <c:orientation val="minMax"/>
          <c:max val="150"/>
          <c:min val="0"/>
        </c:scaling>
        <c:axPos val="l"/>
        <c:majorGridlines/>
        <c:numFmt formatCode="General" sourceLinked="1"/>
        <c:tickLblPos val="nextTo"/>
        <c:crossAx val="82852096"/>
        <c:crosses val="autoZero"/>
        <c:crossBetween val="midCat"/>
        <c:majorUnit val="30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4D497F-53B7-4D8A-AAA8-6F34881DDF11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74DEE-7030-470D-AFCA-47DC9AB93F1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Grp="1"/>
          </p:cNvGraphicFramePr>
          <p:nvPr/>
        </p:nvGraphicFramePr>
        <p:xfrm>
          <a:off x="1331640" y="919753"/>
          <a:ext cx="2880320" cy="21602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246004" y="1800398"/>
            <a:ext cx="1872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Relative CFU at day 12 (%)</a:t>
            </a:r>
            <a:endParaRPr lang="en-GB" sz="1200" dirty="0"/>
          </a:p>
        </p:txBody>
      </p:sp>
      <p:sp>
        <p:nvSpPr>
          <p:cNvPr id="6" name="TextBox 1"/>
          <p:cNvSpPr txBox="1"/>
          <p:nvPr/>
        </p:nvSpPr>
        <p:spPr>
          <a:xfrm>
            <a:off x="1763688" y="2757312"/>
            <a:ext cx="836601" cy="25067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i="1" dirty="0" smtClean="0"/>
              <a:t>rim15∆yak1∆mck1∆</a:t>
            </a:r>
            <a:endParaRPr lang="en-GB" sz="1000" i="1" dirty="0"/>
          </a:p>
        </p:txBody>
      </p:sp>
      <p:sp>
        <p:nvSpPr>
          <p:cNvPr id="7" name="TextBox 1"/>
          <p:cNvSpPr txBox="1"/>
          <p:nvPr/>
        </p:nvSpPr>
        <p:spPr>
          <a:xfrm>
            <a:off x="1979712" y="2575937"/>
            <a:ext cx="724606" cy="250631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i="1" dirty="0" smtClean="0"/>
              <a:t>rim15∆yak1∆</a:t>
            </a:r>
            <a:endParaRPr lang="en-GB" sz="1000" i="1" dirty="0"/>
          </a:p>
        </p:txBody>
      </p:sp>
      <p:sp>
        <p:nvSpPr>
          <p:cNvPr id="8" name="TextBox 1"/>
          <p:cNvSpPr txBox="1"/>
          <p:nvPr/>
        </p:nvSpPr>
        <p:spPr>
          <a:xfrm>
            <a:off x="1403648" y="2431921"/>
            <a:ext cx="836570" cy="25067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i="1" dirty="0" smtClean="0"/>
              <a:t>rim15∆mck1∆</a:t>
            </a:r>
            <a:endParaRPr lang="en-GB" sz="1000" i="1" dirty="0"/>
          </a:p>
        </p:txBody>
      </p:sp>
      <p:sp>
        <p:nvSpPr>
          <p:cNvPr id="9" name="TextBox 1"/>
          <p:cNvSpPr txBox="1"/>
          <p:nvPr/>
        </p:nvSpPr>
        <p:spPr>
          <a:xfrm>
            <a:off x="2267744" y="1495817"/>
            <a:ext cx="724606" cy="250631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i="1" dirty="0" smtClean="0"/>
              <a:t>yak1∆mck1∆</a:t>
            </a:r>
            <a:endParaRPr lang="en-GB" sz="1000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1331640" y="3079993"/>
            <a:ext cx="302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 smtClean="0"/>
              <a:t>Trehalose</a:t>
            </a:r>
            <a:r>
              <a:rPr lang="en-GB" sz="1200" dirty="0" smtClean="0"/>
              <a:t> and glycogen (</a:t>
            </a:r>
            <a:r>
              <a:rPr lang="en-GB" sz="1200" dirty="0" smtClean="0">
                <a:latin typeface="Calibri"/>
              </a:rPr>
              <a:t>µg glucose/mg cells)</a:t>
            </a:r>
            <a:endParaRPr lang="en-GB" sz="1200" dirty="0"/>
          </a:p>
        </p:txBody>
      </p:sp>
      <p:graphicFrame>
        <p:nvGraphicFramePr>
          <p:cNvPr id="11" name="Chart 10"/>
          <p:cNvGraphicFramePr>
            <a:graphicFrameLocks noGrp="1"/>
          </p:cNvGraphicFramePr>
          <p:nvPr/>
        </p:nvGraphicFramePr>
        <p:xfrm>
          <a:off x="4716017" y="847745"/>
          <a:ext cx="2880319" cy="2304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TextBox 1"/>
          <p:cNvSpPr txBox="1"/>
          <p:nvPr/>
        </p:nvSpPr>
        <p:spPr>
          <a:xfrm>
            <a:off x="5004048" y="2791961"/>
            <a:ext cx="836601" cy="25067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i="1" dirty="0" smtClean="0"/>
              <a:t>rim15∆yak1∆mck1∆</a:t>
            </a:r>
            <a:endParaRPr lang="en-GB" sz="1000" i="1" dirty="0"/>
          </a:p>
        </p:txBody>
      </p:sp>
      <p:sp>
        <p:nvSpPr>
          <p:cNvPr id="17" name="TextBox 1"/>
          <p:cNvSpPr txBox="1"/>
          <p:nvPr/>
        </p:nvSpPr>
        <p:spPr>
          <a:xfrm>
            <a:off x="5364088" y="2647945"/>
            <a:ext cx="724606" cy="250631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i="1" dirty="0" smtClean="0"/>
              <a:t>rim15∆yak1∆</a:t>
            </a:r>
            <a:endParaRPr lang="en-GB" sz="1000" i="1" dirty="0"/>
          </a:p>
        </p:txBody>
      </p:sp>
      <p:sp>
        <p:nvSpPr>
          <p:cNvPr id="18" name="TextBox 1"/>
          <p:cNvSpPr txBox="1"/>
          <p:nvPr/>
        </p:nvSpPr>
        <p:spPr>
          <a:xfrm>
            <a:off x="4788024" y="2503929"/>
            <a:ext cx="836570" cy="25067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i="1" dirty="0" smtClean="0"/>
              <a:t>rim15∆mck1∆</a:t>
            </a:r>
            <a:endParaRPr lang="en-GB" sz="1000" i="1" dirty="0"/>
          </a:p>
        </p:txBody>
      </p:sp>
      <p:sp>
        <p:nvSpPr>
          <p:cNvPr id="19" name="TextBox 1"/>
          <p:cNvSpPr txBox="1"/>
          <p:nvPr/>
        </p:nvSpPr>
        <p:spPr>
          <a:xfrm>
            <a:off x="5724128" y="1999873"/>
            <a:ext cx="724606" cy="250631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i="1" dirty="0" smtClean="0"/>
              <a:t>yak1∆mck1∆</a:t>
            </a:r>
            <a:endParaRPr lang="en-GB" sz="1000" i="1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3702388" y="1872406"/>
            <a:ext cx="1872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Relative CFU at day 18 (%)</a:t>
            </a:r>
            <a:endParaRPr lang="en-GB" sz="1200" dirty="0"/>
          </a:p>
        </p:txBody>
      </p:sp>
      <p:sp>
        <p:nvSpPr>
          <p:cNvPr id="21" name="TextBox 20"/>
          <p:cNvSpPr txBox="1"/>
          <p:nvPr/>
        </p:nvSpPr>
        <p:spPr>
          <a:xfrm>
            <a:off x="4788024" y="3079993"/>
            <a:ext cx="302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 smtClean="0"/>
              <a:t>Trehalose</a:t>
            </a:r>
            <a:r>
              <a:rPr lang="en-GB" sz="1200" dirty="0" smtClean="0"/>
              <a:t> and glycogen (</a:t>
            </a:r>
            <a:r>
              <a:rPr lang="en-GB" sz="1200" dirty="0" smtClean="0">
                <a:latin typeface="Calibri"/>
              </a:rPr>
              <a:t>µg glucose/mg cells)</a:t>
            </a:r>
            <a:endParaRPr lang="en-GB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1115616" y="68398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4a</a:t>
            </a:r>
            <a:endParaRPr lang="en-GB" sz="12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572000" y="683984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4b</a:t>
            </a:r>
            <a:endParaRPr lang="en-GB" sz="1200" b="1" dirty="0"/>
          </a:p>
        </p:txBody>
      </p:sp>
      <p:graphicFrame>
        <p:nvGraphicFramePr>
          <p:cNvPr id="24" name="Chart 23"/>
          <p:cNvGraphicFramePr>
            <a:graphicFrameLocks noGrp="1"/>
          </p:cNvGraphicFramePr>
          <p:nvPr/>
        </p:nvGraphicFramePr>
        <p:xfrm>
          <a:off x="1043608" y="3645025"/>
          <a:ext cx="2520280" cy="2088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5" name="Rectangle 24"/>
          <p:cNvSpPr/>
          <p:nvPr/>
        </p:nvSpPr>
        <p:spPr>
          <a:xfrm>
            <a:off x="1619672" y="5229200"/>
            <a:ext cx="7922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1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GB" i="1" dirty="0"/>
              <a:t>g</a:t>
            </a:r>
            <a:r>
              <a:rPr lang="en-GB" dirty="0"/>
              <a:t>sy2∆tps1∆</a:t>
            </a:r>
          </a:p>
        </p:txBody>
      </p:sp>
      <p:sp>
        <p:nvSpPr>
          <p:cNvPr id="26" name="Rectangle 25"/>
          <p:cNvSpPr/>
          <p:nvPr/>
        </p:nvSpPr>
        <p:spPr>
          <a:xfrm>
            <a:off x="1512409" y="4149080"/>
            <a:ext cx="75533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1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GB" i="1" dirty="0"/>
              <a:t>g</a:t>
            </a:r>
            <a:r>
              <a:rPr lang="en-GB" dirty="0"/>
              <a:t>sy2∆tsl1∆</a:t>
            </a:r>
          </a:p>
        </p:txBody>
      </p:sp>
      <p:graphicFrame>
        <p:nvGraphicFramePr>
          <p:cNvPr id="27" name="Chart 26"/>
          <p:cNvGraphicFramePr>
            <a:graphicFrameLocks noGrp="1"/>
          </p:cNvGraphicFramePr>
          <p:nvPr/>
        </p:nvGraphicFramePr>
        <p:xfrm>
          <a:off x="3563889" y="3645024"/>
          <a:ext cx="2520279" cy="208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8" name="Rectangle 27"/>
          <p:cNvSpPr/>
          <p:nvPr/>
        </p:nvSpPr>
        <p:spPr>
          <a:xfrm>
            <a:off x="3995936" y="5229200"/>
            <a:ext cx="7922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1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GB" i="1" dirty="0"/>
              <a:t>g</a:t>
            </a:r>
            <a:r>
              <a:rPr lang="en-GB" dirty="0"/>
              <a:t>sy2∆tps1∆</a:t>
            </a:r>
          </a:p>
        </p:txBody>
      </p:sp>
      <p:sp>
        <p:nvSpPr>
          <p:cNvPr id="29" name="Rectangle 28"/>
          <p:cNvSpPr/>
          <p:nvPr/>
        </p:nvSpPr>
        <p:spPr>
          <a:xfrm>
            <a:off x="4427984" y="4149080"/>
            <a:ext cx="75533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1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GB" i="1" dirty="0"/>
              <a:t>g</a:t>
            </a:r>
            <a:r>
              <a:rPr lang="en-GB" dirty="0"/>
              <a:t>sy2∆tsl1∆</a:t>
            </a:r>
          </a:p>
        </p:txBody>
      </p:sp>
      <p:graphicFrame>
        <p:nvGraphicFramePr>
          <p:cNvPr id="30" name="Chart 29"/>
          <p:cNvGraphicFramePr>
            <a:graphicFrameLocks noGrp="1"/>
          </p:cNvGraphicFramePr>
          <p:nvPr/>
        </p:nvGraphicFramePr>
        <p:xfrm>
          <a:off x="6012160" y="3645024"/>
          <a:ext cx="2520280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1" name="Rectangle 30"/>
          <p:cNvSpPr/>
          <p:nvPr/>
        </p:nvSpPr>
        <p:spPr>
          <a:xfrm>
            <a:off x="6552969" y="4149080"/>
            <a:ext cx="75533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1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GB" i="1" dirty="0"/>
              <a:t>g</a:t>
            </a:r>
            <a:r>
              <a:rPr lang="en-GB" dirty="0"/>
              <a:t>sy2∆tsl1∆</a:t>
            </a:r>
          </a:p>
        </p:txBody>
      </p:sp>
      <p:sp>
        <p:nvSpPr>
          <p:cNvPr id="32" name="Rectangle 31"/>
          <p:cNvSpPr/>
          <p:nvPr/>
        </p:nvSpPr>
        <p:spPr>
          <a:xfrm>
            <a:off x="6444208" y="5229200"/>
            <a:ext cx="7922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1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GB" i="1" dirty="0"/>
              <a:t>g</a:t>
            </a:r>
            <a:r>
              <a:rPr lang="en-GB" dirty="0"/>
              <a:t>sy2∆tps1∆</a:t>
            </a:r>
          </a:p>
        </p:txBody>
      </p:sp>
      <p:sp>
        <p:nvSpPr>
          <p:cNvPr id="33" name="TextBox 32"/>
          <p:cNvSpPr txBox="1"/>
          <p:nvPr/>
        </p:nvSpPr>
        <p:spPr>
          <a:xfrm rot="16200000">
            <a:off x="-42028" y="4525669"/>
            <a:ext cx="1872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Relative CFU at day 14 (%)</a:t>
            </a:r>
            <a:endParaRPr lang="en-GB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1403648" y="5733256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Glycogen (</a:t>
            </a:r>
            <a:r>
              <a:rPr lang="en-GB" sz="1200" dirty="0" smtClean="0">
                <a:latin typeface="Calibri"/>
              </a:rPr>
              <a:t>µg glucose/mg cells)</a:t>
            </a:r>
            <a:endParaRPr lang="en-GB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3995936" y="5733256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 smtClean="0"/>
              <a:t>Trehalose</a:t>
            </a:r>
            <a:r>
              <a:rPr lang="en-GB" sz="1200" dirty="0" smtClean="0"/>
              <a:t> (</a:t>
            </a:r>
            <a:r>
              <a:rPr lang="en-GB" sz="1200" dirty="0" smtClean="0">
                <a:latin typeface="Calibri"/>
              </a:rPr>
              <a:t>µg glucose/mg cells)</a:t>
            </a:r>
            <a:endParaRPr lang="en-GB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6372200" y="5733256"/>
            <a:ext cx="18722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 smtClean="0"/>
              <a:t>Trehalose</a:t>
            </a:r>
            <a:r>
              <a:rPr lang="en-GB" sz="1200" dirty="0" smtClean="0"/>
              <a:t> and glycogen </a:t>
            </a:r>
          </a:p>
          <a:p>
            <a:r>
              <a:rPr lang="en-GB" sz="1200" dirty="0" smtClean="0"/>
              <a:t>(</a:t>
            </a:r>
            <a:r>
              <a:rPr lang="en-GB" sz="1200" dirty="0" smtClean="0">
                <a:latin typeface="Calibri"/>
              </a:rPr>
              <a:t>µg glucose/mg cells)</a:t>
            </a:r>
            <a:endParaRPr lang="en-GB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980262" y="3440033"/>
            <a:ext cx="327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4c</a:t>
            </a:r>
            <a:endParaRPr lang="en-GB" sz="12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3635896" y="3440033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4d</a:t>
            </a:r>
            <a:endParaRPr lang="en-GB" sz="12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6012160" y="3440033"/>
            <a:ext cx="3401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4e</a:t>
            </a:r>
            <a:endParaRPr lang="en-GB" sz="12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827584" y="260648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Supplementary Figure 4</a:t>
            </a:r>
            <a:endParaRPr lang="en-GB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157</Words>
  <Application>Microsoft Office PowerPoint</Application>
  <PresentationFormat>On-screen Show (4:3)</PresentationFormat>
  <Paragraphs>4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Cambridg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z228</dc:creator>
  <cp:lastModifiedBy>nz228</cp:lastModifiedBy>
  <cp:revision>8</cp:revision>
  <dcterms:created xsi:type="dcterms:W3CDTF">2016-09-23T18:46:03Z</dcterms:created>
  <dcterms:modified xsi:type="dcterms:W3CDTF">2016-09-29T13:15:26Z</dcterms:modified>
</cp:coreProperties>
</file>